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7F6F77-D89B-5B6C-185D-55444F9957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7204054-7C59-D56C-B5A4-3649D229FC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1B78272-30E2-9EF7-CBC1-F33B64623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38FE0F-23F2-17C4-272B-C6300F06C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EF1FC78-D516-DF84-00F4-62EAAABE7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2978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7E536C-D2BE-53F7-0052-9EA4FBF931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C4437EC-3435-6942-BF68-8FA126C7DE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A00F48B-992B-5FD6-1FB2-CE5AC0179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F40C714-8D8D-7B25-FA9D-86D094D19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5BD7084-1A3E-BE9E-E482-A2DA60B04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8033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D6CC511-3209-7E0B-F97C-E6927AD440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317705E-07F6-6127-318A-A6889FE116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2FA1D54-576D-884E-BC80-B56430F40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7FDA773-45A6-2CD4-D3F1-1E6895436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769CC7-6CBC-4A6C-2CCF-2B9235EF6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0536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E0D6B3-33F1-F9B3-0749-E51C39F9E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97B25F3-AF82-9643-C421-34BA0C1656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348B63-497C-F85B-CC07-96F76B6EC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31D9EBC-3714-639D-DE90-67BB4125F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F91B21F-163A-FD1C-4EE6-1F8BCB6A3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6749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F95C72-DD66-4C40-AB50-98C23E734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B3E9360-1225-DD78-B8DD-083207DE1D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C55B34-10BB-DDF2-35EA-8A61CF7B1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9CB3C74-51DE-B753-CB00-174E6107F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DD53B1B-ABBA-D1BF-3751-BB58EA5DC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7526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1681EA-FC92-41AE-D893-23A95E9875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CC4387D-6D32-063E-B30F-97E1E0BA38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C1B9DB6-1BDF-A628-48C2-8A14E4E3F6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99FA6E4-EE0D-8432-1E6C-42CB6D86B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43992F8-22B4-247E-30AF-903B148E0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0A8798D-5D4D-BE80-40CD-EB263019B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5364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E03EF5-0F1C-0160-D958-D8E28AAB1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C452D69-FCD3-35EC-98BC-3BDEF4F31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1AF0688-1E1B-08F5-1E5F-B799D25102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ABBCB9F-26F5-C6E9-C52D-72A5CDCDB9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54DD613A-F91A-B5C0-2A23-C350967029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2A73AFA-26C4-AFEB-0EFA-FEB56708D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3924767-188A-0953-0DC6-DDB651FC8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723ED930-08CB-B9E9-A557-4D35D5984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1873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20F27F1-DBC1-1CCE-3945-A50EE0F909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E72E7950-B497-462B-4B36-30144EC40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9981E3F-E82D-8F2B-3289-8A8C078CA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188CF14-1349-6608-FB56-E6DC9E549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9160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0D82403-3EC7-66A7-3D81-E6F067ED6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2E2D277-F6C5-9DA7-CA6B-2AF5F82C2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4B5CE9D-D85E-6CFF-52F8-A06F176D4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6361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5DBF53-178F-6BE7-4921-C768DDEA4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7134A22-3CD5-4C3A-BEBF-67484F5ADD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678E97E-513F-2DB4-B86B-2CB13388F3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E98C8E1-1A0D-375E-A2FE-CC578564D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E5FADE7-537F-E21A-1794-9AD6653EE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4457309-7FC2-C402-5373-581C1D9E4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687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5088D6-A4BE-7D8A-D98D-067632E18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BA41093-5581-607F-E8E2-966930047F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98D24CA-F108-5C0A-116A-73A0D5EB69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C8D43E2-E57B-0644-8E6B-6F6AF3BAD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7C06313-17E6-69D7-4474-0BB39265F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746B664-7530-1842-E26D-99552921A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3068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354CD4D4-E0EA-7073-7FDF-B1B2D3215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A95663F-6F8D-35C5-85D0-8C46627CA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C401509-075A-9B7F-EC1E-14CB5C7C24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9AB8AA-2B95-42E7-95EF-BC032FE09978}" type="datetimeFigureOut">
              <a:rPr lang="es-ES" smtClean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D59E1CC-904C-ED13-D531-D8C445C89C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C632C9F-FEBD-90C3-3A31-EBDFC7A1F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9DE403-0B91-4751-BAC2-8CD675C265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5993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81A67B6D-9821-FD32-84C4-75DA6490B0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4740" y="644525"/>
            <a:ext cx="3610646" cy="1689100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8CEADE89-5058-8C4F-4A6C-6D3AAFA64A6E}"/>
              </a:ext>
            </a:extLst>
          </p:cNvPr>
          <p:cNvSpPr txBox="1"/>
          <p:nvPr/>
        </p:nvSpPr>
        <p:spPr>
          <a:xfrm>
            <a:off x="664740" y="971550"/>
            <a:ext cx="2680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25</a:t>
            </a: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62E6236E-83F7-43E9-B87A-5429888D59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740" y="2470150"/>
            <a:ext cx="3610646" cy="2641285"/>
          </a:xfrm>
          <a:prstGeom prst="rect">
            <a:avLst/>
          </a:prstGeom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0F740AAD-2739-5B10-B01D-0F2F6F25E79B}"/>
              </a:ext>
            </a:extLst>
          </p:cNvPr>
          <p:cNvSpPr txBox="1"/>
          <p:nvPr/>
        </p:nvSpPr>
        <p:spPr>
          <a:xfrm>
            <a:off x="693315" y="2549267"/>
            <a:ext cx="2680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75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8190BDA2-D70E-BC7C-8D9A-4707865E31CF}"/>
              </a:ext>
            </a:extLst>
          </p:cNvPr>
          <p:cNvSpPr txBox="1"/>
          <p:nvPr/>
        </p:nvSpPr>
        <p:spPr>
          <a:xfrm>
            <a:off x="693315" y="2968367"/>
            <a:ext cx="2680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5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209070CF-5584-4E1E-C96F-B8CF48790303}"/>
              </a:ext>
            </a:extLst>
          </p:cNvPr>
          <p:cNvSpPr txBox="1"/>
          <p:nvPr/>
        </p:nvSpPr>
        <p:spPr>
          <a:xfrm>
            <a:off x="706015" y="3336667"/>
            <a:ext cx="2680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37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2C365F95-6FDD-A8DC-71DA-49BDAA4FA20F}"/>
              </a:ext>
            </a:extLst>
          </p:cNvPr>
          <p:cNvSpPr txBox="1"/>
          <p:nvPr/>
        </p:nvSpPr>
        <p:spPr>
          <a:xfrm>
            <a:off x="2941215" y="1098550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DJ-1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080296F-A68D-7D60-E542-93AF41790685}"/>
              </a:ext>
            </a:extLst>
          </p:cNvPr>
          <p:cNvSpPr txBox="1"/>
          <p:nvPr/>
        </p:nvSpPr>
        <p:spPr>
          <a:xfrm>
            <a:off x="3430165" y="3257034"/>
            <a:ext cx="47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pERK1/2</a:t>
            </a:r>
          </a:p>
        </p:txBody>
      </p: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30752D67-92CC-1420-20EE-09E646C326AC}"/>
              </a:ext>
            </a:extLst>
          </p:cNvPr>
          <p:cNvCxnSpPr/>
          <p:nvPr/>
        </p:nvCxnSpPr>
        <p:spPr>
          <a:xfrm>
            <a:off x="2336800" y="774700"/>
            <a:ext cx="5334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2CFA935F-05E2-025C-CD7A-0E2F8B165639}"/>
              </a:ext>
            </a:extLst>
          </p:cNvPr>
          <p:cNvCxnSpPr/>
          <p:nvPr/>
        </p:nvCxnSpPr>
        <p:spPr>
          <a:xfrm>
            <a:off x="1714500" y="774700"/>
            <a:ext cx="5334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3B6F4D44-9C33-D18D-FF2E-4EF9B9689DCD}"/>
              </a:ext>
            </a:extLst>
          </p:cNvPr>
          <p:cNvSpPr txBox="1"/>
          <p:nvPr/>
        </p:nvSpPr>
        <p:spPr>
          <a:xfrm>
            <a:off x="1714500" y="422374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WT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07837AA5-A7CE-BFD7-FBB3-C81E2B058282}"/>
              </a:ext>
            </a:extLst>
          </p:cNvPr>
          <p:cNvSpPr txBox="1"/>
          <p:nvPr/>
        </p:nvSpPr>
        <p:spPr>
          <a:xfrm>
            <a:off x="2253083" y="422374"/>
            <a:ext cx="700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G</a:t>
            </a:r>
            <a:r>
              <a:rPr lang="el-GR" sz="700" dirty="0"/>
              <a:t>α</a:t>
            </a:r>
            <a:r>
              <a:rPr lang="es-ES" sz="700" dirty="0" err="1"/>
              <a:t>qKO</a:t>
            </a:r>
            <a:endParaRPr lang="es-ES" sz="700" dirty="0"/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28F95C00-279D-16D7-BFCE-C868A6B9C939}"/>
              </a:ext>
            </a:extLst>
          </p:cNvPr>
          <p:cNvCxnSpPr>
            <a:cxnSpLocks/>
          </p:cNvCxnSpPr>
          <p:nvPr/>
        </p:nvCxnSpPr>
        <p:spPr>
          <a:xfrm>
            <a:off x="2603500" y="3034982"/>
            <a:ext cx="63573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id="{75CA33AB-EF2A-A348-634D-DDFB8F89E82A}"/>
              </a:ext>
            </a:extLst>
          </p:cNvPr>
          <p:cNvCxnSpPr>
            <a:cxnSpLocks/>
          </p:cNvCxnSpPr>
          <p:nvPr/>
        </p:nvCxnSpPr>
        <p:spPr>
          <a:xfrm>
            <a:off x="1885950" y="3034982"/>
            <a:ext cx="60281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CuadroTexto 28">
            <a:extLst>
              <a:ext uri="{FF2B5EF4-FFF2-40B4-BE49-F238E27FC236}">
                <a16:creationId xmlns:a16="http://schemas.microsoft.com/office/drawing/2014/main" id="{B1119E3A-D4C2-4A21-6D9A-F0219B3895B9}"/>
              </a:ext>
            </a:extLst>
          </p:cNvPr>
          <p:cNvSpPr txBox="1"/>
          <p:nvPr/>
        </p:nvSpPr>
        <p:spPr>
          <a:xfrm>
            <a:off x="1999818" y="2685990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WT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86C8C645-B7FA-6B9D-95E3-3F97EFDB793D}"/>
              </a:ext>
            </a:extLst>
          </p:cNvPr>
          <p:cNvSpPr txBox="1"/>
          <p:nvPr/>
        </p:nvSpPr>
        <p:spPr>
          <a:xfrm>
            <a:off x="2538401" y="2685990"/>
            <a:ext cx="700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G</a:t>
            </a:r>
            <a:r>
              <a:rPr lang="el-GR" sz="700" dirty="0"/>
              <a:t>α</a:t>
            </a:r>
            <a:r>
              <a:rPr lang="es-ES" sz="700" dirty="0" err="1"/>
              <a:t>qKO</a:t>
            </a:r>
            <a:endParaRPr lang="es-ES" sz="700" dirty="0"/>
          </a:p>
        </p:txBody>
      </p:sp>
      <p:pic>
        <p:nvPicPr>
          <p:cNvPr id="34" name="Imagen 33">
            <a:extLst>
              <a:ext uri="{FF2B5EF4-FFF2-40B4-BE49-F238E27FC236}">
                <a16:creationId xmlns:a16="http://schemas.microsoft.com/office/drawing/2014/main" id="{DBA1A481-AB5C-C6B7-9362-1CC97848B6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24375" y="576262"/>
            <a:ext cx="4141707" cy="1689100"/>
          </a:xfrm>
          <a:prstGeom prst="rect">
            <a:avLst/>
          </a:prstGeom>
        </p:spPr>
      </p:pic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CFA12241-04DC-4EE8-DDAD-3791C8D3EE9E}"/>
              </a:ext>
            </a:extLst>
          </p:cNvPr>
          <p:cNvCxnSpPr/>
          <p:nvPr/>
        </p:nvCxnSpPr>
        <p:spPr>
          <a:xfrm>
            <a:off x="6550660" y="978118"/>
            <a:ext cx="5334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id="{3C3B14E5-F2DD-8E65-F85F-142DFBF3D580}"/>
              </a:ext>
            </a:extLst>
          </p:cNvPr>
          <p:cNvCxnSpPr/>
          <p:nvPr/>
        </p:nvCxnSpPr>
        <p:spPr>
          <a:xfrm>
            <a:off x="5928360" y="978118"/>
            <a:ext cx="5334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CuadroTexto 36">
            <a:extLst>
              <a:ext uri="{FF2B5EF4-FFF2-40B4-BE49-F238E27FC236}">
                <a16:creationId xmlns:a16="http://schemas.microsoft.com/office/drawing/2014/main" id="{50DF6737-7C1D-FDD7-320B-58096B37A91E}"/>
              </a:ext>
            </a:extLst>
          </p:cNvPr>
          <p:cNvSpPr txBox="1"/>
          <p:nvPr/>
        </p:nvSpPr>
        <p:spPr>
          <a:xfrm>
            <a:off x="5928360" y="625792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WT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41451DD5-6EA1-1E1A-EB65-1C3BE91B9B8A}"/>
              </a:ext>
            </a:extLst>
          </p:cNvPr>
          <p:cNvSpPr txBox="1"/>
          <p:nvPr/>
        </p:nvSpPr>
        <p:spPr>
          <a:xfrm>
            <a:off x="6466943" y="625792"/>
            <a:ext cx="700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G</a:t>
            </a:r>
            <a:r>
              <a:rPr lang="el-GR" sz="700" dirty="0"/>
              <a:t>α</a:t>
            </a:r>
            <a:r>
              <a:rPr lang="es-ES" sz="700" dirty="0" err="1"/>
              <a:t>qKO</a:t>
            </a:r>
            <a:endParaRPr lang="es-ES" sz="700" dirty="0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E91AC21A-F454-EBF4-C44E-91F7942BB67E}"/>
              </a:ext>
            </a:extLst>
          </p:cNvPr>
          <p:cNvSpPr txBox="1"/>
          <p:nvPr/>
        </p:nvSpPr>
        <p:spPr>
          <a:xfrm>
            <a:off x="4741098" y="978118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250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6368637F-FC91-0992-CEF5-8D63EDDA9E1C}"/>
              </a:ext>
            </a:extLst>
          </p:cNvPr>
          <p:cNvSpPr txBox="1"/>
          <p:nvPr/>
        </p:nvSpPr>
        <p:spPr>
          <a:xfrm>
            <a:off x="4741098" y="1156216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150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C6B6CC55-3E22-AB9E-B183-59CAD77C1973}"/>
              </a:ext>
            </a:extLst>
          </p:cNvPr>
          <p:cNvSpPr txBox="1"/>
          <p:nvPr/>
        </p:nvSpPr>
        <p:spPr>
          <a:xfrm>
            <a:off x="4741098" y="1348025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100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15C1BED1-36E2-F5D8-4C02-ECDDC9899198}"/>
              </a:ext>
            </a:extLst>
          </p:cNvPr>
          <p:cNvSpPr txBox="1"/>
          <p:nvPr/>
        </p:nvSpPr>
        <p:spPr>
          <a:xfrm>
            <a:off x="7167777" y="1255692"/>
            <a:ext cx="5293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 err="1"/>
              <a:t>eCadherin</a:t>
            </a:r>
            <a:endParaRPr lang="es-ES" sz="600" dirty="0"/>
          </a:p>
        </p:txBody>
      </p:sp>
      <p:sp>
        <p:nvSpPr>
          <p:cNvPr id="44" name="Rectángulo 43">
            <a:extLst>
              <a:ext uri="{FF2B5EF4-FFF2-40B4-BE49-F238E27FC236}">
                <a16:creationId xmlns:a16="http://schemas.microsoft.com/office/drawing/2014/main" id="{BC30B540-9554-035D-223F-B6DC3C9A7C97}"/>
              </a:ext>
            </a:extLst>
          </p:cNvPr>
          <p:cNvSpPr/>
          <p:nvPr/>
        </p:nvSpPr>
        <p:spPr>
          <a:xfrm>
            <a:off x="1885950" y="1063883"/>
            <a:ext cx="845344" cy="219333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5" name="Rectángulo 44">
            <a:extLst>
              <a:ext uri="{FF2B5EF4-FFF2-40B4-BE49-F238E27FC236}">
                <a16:creationId xmlns:a16="http://schemas.microsoft.com/office/drawing/2014/main" id="{D557FC56-93A3-CFBA-B583-8120A800DA0B}"/>
              </a:ext>
            </a:extLst>
          </p:cNvPr>
          <p:cNvSpPr/>
          <p:nvPr/>
        </p:nvSpPr>
        <p:spPr>
          <a:xfrm>
            <a:off x="2076023" y="3214925"/>
            <a:ext cx="940228" cy="277574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" name="Rectángulo 45">
            <a:extLst>
              <a:ext uri="{FF2B5EF4-FFF2-40B4-BE49-F238E27FC236}">
                <a16:creationId xmlns:a16="http://schemas.microsoft.com/office/drawing/2014/main" id="{DF02FF49-C1CB-1649-200D-F711000C75CA}"/>
              </a:ext>
            </a:extLst>
          </p:cNvPr>
          <p:cNvSpPr/>
          <p:nvPr/>
        </p:nvSpPr>
        <p:spPr>
          <a:xfrm>
            <a:off x="6080546" y="1209238"/>
            <a:ext cx="914614" cy="277574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48" name="Imagen 47">
            <a:extLst>
              <a:ext uri="{FF2B5EF4-FFF2-40B4-BE49-F238E27FC236}">
                <a16:creationId xmlns:a16="http://schemas.microsoft.com/office/drawing/2014/main" id="{6819DF75-E31D-D418-2ED6-50E5E0EB3E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9300" y="2730500"/>
            <a:ext cx="3728952" cy="2455651"/>
          </a:xfrm>
          <a:prstGeom prst="rect">
            <a:avLst/>
          </a:prstGeom>
        </p:spPr>
      </p:pic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id="{226A68E8-544E-DB8A-D769-BCE3FA5B21E1}"/>
              </a:ext>
            </a:extLst>
          </p:cNvPr>
          <p:cNvCxnSpPr/>
          <p:nvPr/>
        </p:nvCxnSpPr>
        <p:spPr>
          <a:xfrm>
            <a:off x="6634377" y="2748041"/>
            <a:ext cx="5334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>
            <a:extLst>
              <a:ext uri="{FF2B5EF4-FFF2-40B4-BE49-F238E27FC236}">
                <a16:creationId xmlns:a16="http://schemas.microsoft.com/office/drawing/2014/main" id="{EDC3BE4A-926C-BB12-1C29-BE4B0F6ABBF5}"/>
              </a:ext>
            </a:extLst>
          </p:cNvPr>
          <p:cNvCxnSpPr/>
          <p:nvPr/>
        </p:nvCxnSpPr>
        <p:spPr>
          <a:xfrm>
            <a:off x="6012077" y="2748041"/>
            <a:ext cx="5334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CuadroTexto 50">
            <a:extLst>
              <a:ext uri="{FF2B5EF4-FFF2-40B4-BE49-F238E27FC236}">
                <a16:creationId xmlns:a16="http://schemas.microsoft.com/office/drawing/2014/main" id="{43402950-7F1E-95D2-16CC-6FE2E1DAA33A}"/>
              </a:ext>
            </a:extLst>
          </p:cNvPr>
          <p:cNvSpPr txBox="1"/>
          <p:nvPr/>
        </p:nvSpPr>
        <p:spPr>
          <a:xfrm>
            <a:off x="6012077" y="2395715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WT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CAD8937F-DAAC-47BD-6401-B8BC6732225D}"/>
              </a:ext>
            </a:extLst>
          </p:cNvPr>
          <p:cNvSpPr txBox="1"/>
          <p:nvPr/>
        </p:nvSpPr>
        <p:spPr>
          <a:xfrm>
            <a:off x="6550660" y="2395715"/>
            <a:ext cx="700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/>
              <a:t>Cal27 </a:t>
            </a:r>
          </a:p>
          <a:p>
            <a:pPr algn="ctr"/>
            <a:r>
              <a:rPr lang="es-ES" sz="700" dirty="0"/>
              <a:t>+ </a:t>
            </a:r>
            <a:r>
              <a:rPr lang="es-ES" sz="700" dirty="0" err="1"/>
              <a:t>Sup</a:t>
            </a:r>
            <a:r>
              <a:rPr lang="es-ES" sz="700" dirty="0"/>
              <a:t> G</a:t>
            </a:r>
            <a:r>
              <a:rPr lang="el-GR" sz="700" dirty="0"/>
              <a:t>α</a:t>
            </a:r>
            <a:r>
              <a:rPr lang="es-ES" sz="700" dirty="0" err="1"/>
              <a:t>qKO</a:t>
            </a:r>
            <a:endParaRPr lang="es-ES" sz="700" dirty="0"/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F7FB2813-8C3E-3439-B544-796F1E779A2E}"/>
              </a:ext>
            </a:extLst>
          </p:cNvPr>
          <p:cNvSpPr txBox="1"/>
          <p:nvPr/>
        </p:nvSpPr>
        <p:spPr>
          <a:xfrm>
            <a:off x="7167777" y="3501766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ERK1/2</a:t>
            </a:r>
          </a:p>
        </p:txBody>
      </p:sp>
      <p:sp>
        <p:nvSpPr>
          <p:cNvPr id="54" name="Rectángulo 53">
            <a:extLst>
              <a:ext uri="{FF2B5EF4-FFF2-40B4-BE49-F238E27FC236}">
                <a16:creationId xmlns:a16="http://schemas.microsoft.com/office/drawing/2014/main" id="{B51072FC-D06D-07F6-03FA-04CC8400AC25}"/>
              </a:ext>
            </a:extLst>
          </p:cNvPr>
          <p:cNvSpPr/>
          <p:nvPr/>
        </p:nvSpPr>
        <p:spPr>
          <a:xfrm>
            <a:off x="6146800" y="3501766"/>
            <a:ext cx="848360" cy="231120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8E5FD342-70D4-DFEB-EEC3-A1D52A8DC80E}"/>
              </a:ext>
            </a:extLst>
          </p:cNvPr>
          <p:cNvSpPr txBox="1"/>
          <p:nvPr/>
        </p:nvSpPr>
        <p:spPr>
          <a:xfrm>
            <a:off x="4699860" y="3179920"/>
            <a:ext cx="2680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50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0909E6F9-FC1E-7272-DAB0-A66D2ECDCFA8}"/>
              </a:ext>
            </a:extLst>
          </p:cNvPr>
          <p:cNvSpPr txBox="1"/>
          <p:nvPr/>
        </p:nvSpPr>
        <p:spPr>
          <a:xfrm>
            <a:off x="4712560" y="3548220"/>
            <a:ext cx="2680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/>
              <a:t>37</a:t>
            </a:r>
          </a:p>
        </p:txBody>
      </p:sp>
    </p:spTree>
    <p:extLst>
      <p:ext uri="{BB962C8B-B14F-4D97-AF65-F5344CB8AC3E}">
        <p14:creationId xmlns:p14="http://schemas.microsoft.com/office/powerpoint/2010/main" val="23532103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3</Words>
  <Application>Microsoft Office PowerPoint</Application>
  <PresentationFormat>Panorámica</PresentationFormat>
  <Paragraphs>2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quel Huertas Larez</dc:creator>
  <cp:lastModifiedBy>Raquel Huertas Larez</cp:lastModifiedBy>
  <cp:revision>1</cp:revision>
  <dcterms:created xsi:type="dcterms:W3CDTF">2025-12-02T13:23:06Z</dcterms:created>
  <dcterms:modified xsi:type="dcterms:W3CDTF">2025-12-02T13:38:30Z</dcterms:modified>
</cp:coreProperties>
</file>